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9" r:id="rId2"/>
    <p:sldId id="320" r:id="rId3"/>
    <p:sldId id="321" r:id="rId4"/>
    <p:sldId id="315" r:id="rId5"/>
    <p:sldId id="316" r:id="rId6"/>
    <p:sldId id="318" r:id="rId7"/>
    <p:sldId id="317" r:id="rId8"/>
    <p:sldId id="260" r:id="rId9"/>
    <p:sldId id="290" r:id="rId10"/>
    <p:sldId id="305" r:id="rId11"/>
  </p:sldIdLst>
  <p:sldSz cx="10799763" cy="16256000"/>
  <p:notesSz cx="6669088" cy="9872663"/>
  <p:defaultTextStyle>
    <a:defPPr>
      <a:defRPr lang="en-DE"/>
    </a:defPPr>
    <a:lvl1pPr marL="0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43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87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30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72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17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59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03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46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81A"/>
    <a:srgbClr val="FA2500"/>
    <a:srgbClr val="FFD379"/>
    <a:srgbClr val="921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93235" autoAdjust="0"/>
  </p:normalViewPr>
  <p:slideViewPr>
    <p:cSldViewPr snapToGrid="0">
      <p:cViewPr>
        <p:scale>
          <a:sx n="75" d="100"/>
          <a:sy n="75" d="100"/>
        </p:scale>
        <p:origin x="2724" y="-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FDFFA-25BA-0293-BD8D-E383E7BA50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49971" y="2660415"/>
            <a:ext cx="8099823" cy="5659496"/>
          </a:xfrm>
        </p:spPr>
        <p:txBody>
          <a:bodyPr anchor="b"/>
          <a:lstStyle>
            <a:lvl1pPr algn="ctr">
              <a:defRPr sz="9448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616403-3C29-6AEA-BBD8-A9860EA9EF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49971" y="8538168"/>
            <a:ext cx="8099823" cy="3924769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44" indent="0" algn="ctr">
              <a:buNone/>
              <a:defRPr sz="3150"/>
            </a:lvl2pPr>
            <a:lvl3pPr marL="1439890" indent="0" algn="ctr">
              <a:buNone/>
              <a:defRPr sz="2835"/>
            </a:lvl3pPr>
            <a:lvl4pPr marL="2159836" indent="0" algn="ctr">
              <a:buNone/>
              <a:defRPr sz="2519"/>
            </a:lvl4pPr>
            <a:lvl5pPr marL="2879781" indent="0" algn="ctr">
              <a:buNone/>
              <a:defRPr sz="2519"/>
            </a:lvl5pPr>
            <a:lvl6pPr marL="3599725" indent="0" algn="ctr">
              <a:buNone/>
              <a:defRPr sz="2519"/>
            </a:lvl6pPr>
            <a:lvl7pPr marL="4319671" indent="0" algn="ctr">
              <a:buNone/>
              <a:defRPr sz="2519"/>
            </a:lvl7pPr>
            <a:lvl8pPr marL="5039616" indent="0" algn="ctr">
              <a:buNone/>
              <a:defRPr sz="2519"/>
            </a:lvl8pPr>
            <a:lvl9pPr marL="5759562" indent="0" algn="ctr">
              <a:buNone/>
              <a:defRPr sz="2519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83BECD-4813-0022-E1B4-889A38D36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106C8-6F4A-0053-DF52-A8EE3CC0F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6BA2B1-4E7B-9704-6494-3BA58EBCC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0517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5C553-8FA5-C343-AED8-F37351A1EA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619B89-AE0F-92D6-8DED-1E1C635585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FA227A-4F23-4E2D-9606-A2EB0325B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16280-DE8D-B7C9-7B2E-4A90A5384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7934B-AB96-E93B-EB48-48054DB81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58473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2C80F4-6681-6985-DF11-9BC91C258C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728583" y="865482"/>
            <a:ext cx="2328698" cy="1377620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FFAB68-3F76-9130-31FC-5261FFFFC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742485" y="865482"/>
            <a:ext cx="6851101" cy="1377620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C927C5-5B79-EBA7-43AE-FCE4900B0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105E80-4EB1-F5FC-032F-CA708528F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A3A70-C7F4-5A71-5ED1-046A79972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20207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03B54-D2AB-04A8-72C0-86D788449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0FAF1D-69D1-D6A2-177D-C8F3B5FF74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5E1EFF-1175-0BF2-19C8-B774B6152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92FC1-E3D1-CCA2-CE99-0B4C5A780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1F1BB-4F0C-4EAC-DD0D-368E56805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1617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C9ED67-42A9-5337-414C-53E6391C8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6860" y="4052715"/>
            <a:ext cx="9314796" cy="6762043"/>
          </a:xfrm>
        </p:spPr>
        <p:txBody>
          <a:bodyPr anchor="b"/>
          <a:lstStyle>
            <a:lvl1pPr>
              <a:defRPr sz="9448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CFFA26-A268-6490-A855-AFB96AAC6E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36860" y="10878732"/>
            <a:ext cx="9314796" cy="3555999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1pPr>
            <a:lvl2pPr marL="71994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89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836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4pPr>
            <a:lvl5pPr marL="2879781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5pPr>
            <a:lvl6pPr marL="3599725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6pPr>
            <a:lvl7pPr marL="4319671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7pPr>
            <a:lvl8pPr marL="5039616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8pPr>
            <a:lvl9pPr marL="5759562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2B27A1-A20A-F266-017D-094269E0B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93E1EA-7004-3532-5196-DC586A2BF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5B53FB-B915-9652-C019-EE201E945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83324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74030-BE7A-7CD7-2676-C83197AD5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AC6C94-1C4E-AA7F-A1E3-991FF204B0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742486" y="4327410"/>
            <a:ext cx="4589899" cy="1031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E5C9D8-41C0-4728-9196-A3434767E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467381" y="4327410"/>
            <a:ext cx="4589899" cy="1031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6F3778-4172-5586-E0C1-35E2F471A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C256AF-9E72-F0EB-C5B9-D9202C47A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32DEDD-3065-2605-625D-A2A25F15E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59919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7F950-2D11-6605-FA33-61996BB607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1" y="865484"/>
            <a:ext cx="9314796" cy="314207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CACC26-4EC6-B85B-61D7-50FCA9C197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43892" y="3984980"/>
            <a:ext cx="4568806" cy="1952976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44" indent="0">
              <a:buNone/>
              <a:defRPr sz="3150" b="1"/>
            </a:lvl2pPr>
            <a:lvl3pPr marL="1439890" indent="0">
              <a:buNone/>
              <a:defRPr sz="2835" b="1"/>
            </a:lvl3pPr>
            <a:lvl4pPr marL="2159836" indent="0">
              <a:buNone/>
              <a:defRPr sz="2519" b="1"/>
            </a:lvl4pPr>
            <a:lvl5pPr marL="2879781" indent="0">
              <a:buNone/>
              <a:defRPr sz="2519" b="1"/>
            </a:lvl5pPr>
            <a:lvl6pPr marL="3599725" indent="0">
              <a:buNone/>
              <a:defRPr sz="2519" b="1"/>
            </a:lvl6pPr>
            <a:lvl7pPr marL="4319671" indent="0">
              <a:buNone/>
              <a:defRPr sz="2519" b="1"/>
            </a:lvl7pPr>
            <a:lvl8pPr marL="5039616" indent="0">
              <a:buNone/>
              <a:defRPr sz="2519" b="1"/>
            </a:lvl8pPr>
            <a:lvl9pPr marL="5759562" indent="0">
              <a:buNone/>
              <a:defRPr sz="251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718B2B-DCAE-097C-BCB8-B312E171F2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43892" y="5937959"/>
            <a:ext cx="4568806" cy="8733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6F2468-380E-A5E1-7CE7-6DF11CFC6B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467381" y="3984980"/>
            <a:ext cx="4591306" cy="1952976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44" indent="0">
              <a:buNone/>
              <a:defRPr sz="3150" b="1"/>
            </a:lvl2pPr>
            <a:lvl3pPr marL="1439890" indent="0">
              <a:buNone/>
              <a:defRPr sz="2835" b="1"/>
            </a:lvl3pPr>
            <a:lvl4pPr marL="2159836" indent="0">
              <a:buNone/>
              <a:defRPr sz="2519" b="1"/>
            </a:lvl4pPr>
            <a:lvl5pPr marL="2879781" indent="0">
              <a:buNone/>
              <a:defRPr sz="2519" b="1"/>
            </a:lvl5pPr>
            <a:lvl6pPr marL="3599725" indent="0">
              <a:buNone/>
              <a:defRPr sz="2519" b="1"/>
            </a:lvl6pPr>
            <a:lvl7pPr marL="4319671" indent="0">
              <a:buNone/>
              <a:defRPr sz="2519" b="1"/>
            </a:lvl7pPr>
            <a:lvl8pPr marL="5039616" indent="0">
              <a:buNone/>
              <a:defRPr sz="2519" b="1"/>
            </a:lvl8pPr>
            <a:lvl9pPr marL="5759562" indent="0">
              <a:buNone/>
              <a:defRPr sz="251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F7E072-B372-7495-DEC4-D8A3188CB2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467381" y="5937959"/>
            <a:ext cx="4591306" cy="8733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338556-E0C9-4F13-67E4-47050CBA2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EA690D-9543-64B9-5000-48949CF87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5F2086-B6B1-54CD-3C2E-092069E77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93753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9DD79-EB8A-6ABF-9BCD-1C6EB4843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2D059B-674D-203E-D42A-7D12CDE75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49DD75-9E0F-CE34-8118-D7CDBA355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450052-3781-4A9A-0B78-359AA5A6F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41463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34C3D7-F8F6-A009-0120-7BB142601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16A7D0-60D2-A2DA-3377-B93433D62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DFE8E2-656F-1042-0F07-3419BD033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20792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5A567-B3A6-2133-332B-43D0D6F20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4" y="1083734"/>
            <a:ext cx="3483203" cy="379306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9506E8-5324-AE45-18A7-B8A29BCC8E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91309" y="2340565"/>
            <a:ext cx="5467381" cy="11552296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C7A6C0-DA4B-B923-9FEF-9B6435AE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743894" y="4876802"/>
            <a:ext cx="3483203" cy="9034875"/>
          </a:xfrm>
        </p:spPr>
        <p:txBody>
          <a:bodyPr/>
          <a:lstStyle>
            <a:lvl1pPr marL="0" indent="0">
              <a:buNone/>
              <a:defRPr sz="2519"/>
            </a:lvl1pPr>
            <a:lvl2pPr marL="719944" indent="0">
              <a:buNone/>
              <a:defRPr sz="2207"/>
            </a:lvl2pPr>
            <a:lvl3pPr marL="1439890" indent="0">
              <a:buNone/>
              <a:defRPr sz="1889"/>
            </a:lvl3pPr>
            <a:lvl4pPr marL="2159836" indent="0">
              <a:buNone/>
              <a:defRPr sz="1577"/>
            </a:lvl4pPr>
            <a:lvl5pPr marL="2879781" indent="0">
              <a:buNone/>
              <a:defRPr sz="1577"/>
            </a:lvl5pPr>
            <a:lvl6pPr marL="3599725" indent="0">
              <a:buNone/>
              <a:defRPr sz="1577"/>
            </a:lvl6pPr>
            <a:lvl7pPr marL="4319671" indent="0">
              <a:buNone/>
              <a:defRPr sz="1577"/>
            </a:lvl7pPr>
            <a:lvl8pPr marL="5039616" indent="0">
              <a:buNone/>
              <a:defRPr sz="1577"/>
            </a:lvl8pPr>
            <a:lvl9pPr marL="575956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C7EFBA-21E6-8AAE-BCBE-588B1A760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E051DD-24C9-1B04-E740-AF90D0600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323301-FD88-9E2B-96B2-2CB9E320D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43609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E5D11F-7D5D-A4A8-160D-E91E6A6E3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4" y="1083734"/>
            <a:ext cx="3483203" cy="379306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E8D029-50F9-2135-ED13-61F7FB055A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591309" y="2340565"/>
            <a:ext cx="5467381" cy="11552296"/>
          </a:xfrm>
        </p:spPr>
        <p:txBody>
          <a:bodyPr/>
          <a:lstStyle>
            <a:lvl1pPr marL="0" indent="0">
              <a:buNone/>
              <a:defRPr sz="5039"/>
            </a:lvl1pPr>
            <a:lvl2pPr marL="719944" indent="0">
              <a:buNone/>
              <a:defRPr sz="4409"/>
            </a:lvl2pPr>
            <a:lvl3pPr marL="1439890" indent="0">
              <a:buNone/>
              <a:defRPr sz="3780"/>
            </a:lvl3pPr>
            <a:lvl4pPr marL="2159836" indent="0">
              <a:buNone/>
              <a:defRPr sz="3150"/>
            </a:lvl4pPr>
            <a:lvl5pPr marL="2879781" indent="0">
              <a:buNone/>
              <a:defRPr sz="3150"/>
            </a:lvl5pPr>
            <a:lvl6pPr marL="3599725" indent="0">
              <a:buNone/>
              <a:defRPr sz="3150"/>
            </a:lvl6pPr>
            <a:lvl7pPr marL="4319671" indent="0">
              <a:buNone/>
              <a:defRPr sz="3150"/>
            </a:lvl7pPr>
            <a:lvl8pPr marL="5039616" indent="0">
              <a:buNone/>
              <a:defRPr sz="3150"/>
            </a:lvl8pPr>
            <a:lvl9pPr marL="5759562" indent="0">
              <a:buNone/>
              <a:defRPr sz="315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08DE73-2BC0-DC89-2674-9E1DC3BDA2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743894" y="4876802"/>
            <a:ext cx="3483203" cy="9034875"/>
          </a:xfrm>
        </p:spPr>
        <p:txBody>
          <a:bodyPr/>
          <a:lstStyle>
            <a:lvl1pPr marL="0" indent="0">
              <a:buNone/>
              <a:defRPr sz="2519"/>
            </a:lvl1pPr>
            <a:lvl2pPr marL="719944" indent="0">
              <a:buNone/>
              <a:defRPr sz="2207"/>
            </a:lvl2pPr>
            <a:lvl3pPr marL="1439890" indent="0">
              <a:buNone/>
              <a:defRPr sz="1889"/>
            </a:lvl3pPr>
            <a:lvl4pPr marL="2159836" indent="0">
              <a:buNone/>
              <a:defRPr sz="1577"/>
            </a:lvl4pPr>
            <a:lvl5pPr marL="2879781" indent="0">
              <a:buNone/>
              <a:defRPr sz="1577"/>
            </a:lvl5pPr>
            <a:lvl6pPr marL="3599725" indent="0">
              <a:buNone/>
              <a:defRPr sz="1577"/>
            </a:lvl6pPr>
            <a:lvl7pPr marL="4319671" indent="0">
              <a:buNone/>
              <a:defRPr sz="1577"/>
            </a:lvl7pPr>
            <a:lvl8pPr marL="5039616" indent="0">
              <a:buNone/>
              <a:defRPr sz="1577"/>
            </a:lvl8pPr>
            <a:lvl9pPr marL="575956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07022D-9932-1790-A1FE-96736180A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13648F-6F22-82EB-ADAF-FEB431E80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84CF00-DA06-AFB7-EAA8-AA453FFD5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60592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797AF9-8C03-9931-1488-F1583F0A6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2484" y="865484"/>
            <a:ext cx="9314796" cy="31420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97E572-50D4-90BB-167C-AB6F2D99A0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42484" y="4327410"/>
            <a:ext cx="9314796" cy="1031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056448-CD5C-39F9-D0C7-F5F585F9F2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742484" y="15066910"/>
            <a:ext cx="2429948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7CCF97-D789-4479-B8DA-E34374C52551}" type="datetimeFigureOut">
              <a:rPr lang="en-DE" smtClean="0"/>
              <a:t>04/10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9CBFBF-B811-6283-66FB-96A60D9E6D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577422" y="15066910"/>
            <a:ext cx="3644920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0BD45-8F0C-4D0E-09DB-A8F703E2CB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627333" y="15066910"/>
            <a:ext cx="2429948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34176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39890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74" indent="-359974" algn="l" defTabSz="1439890" rtl="0" eaLnBrk="1" latinLnBrk="0" hangingPunct="1">
        <a:lnSpc>
          <a:spcPct val="90000"/>
        </a:lnSpc>
        <a:spcBef>
          <a:spcPts val="1577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2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863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809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754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70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646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59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536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44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890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836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781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725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671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616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562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image" Target="../media/image31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12" Type="http://schemas.openxmlformats.org/officeDocument/2006/relationships/image" Target="../media/image30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11" Type="http://schemas.openxmlformats.org/officeDocument/2006/relationships/image" Target="../media/image29.emf"/><Relationship Id="rId5" Type="http://schemas.openxmlformats.org/officeDocument/2006/relationships/image" Target="../media/image23.emf"/><Relationship Id="rId10" Type="http://schemas.openxmlformats.org/officeDocument/2006/relationships/image" Target="../media/image28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7" Type="http://schemas.openxmlformats.org/officeDocument/2006/relationships/image" Target="../media/image10.em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10" Type="http://schemas.openxmlformats.org/officeDocument/2006/relationships/image" Target="../media/image19.emf"/><Relationship Id="rId4" Type="http://schemas.openxmlformats.org/officeDocument/2006/relationships/image" Target="../media/image13.emf"/><Relationship Id="rId9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398704" y="809207"/>
            <a:ext cx="9977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 characteristics in tissue immunohistochemistry analyses</a:t>
            </a:r>
            <a:endParaRPr 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0472534"/>
              </p:ext>
            </p:extLst>
          </p:nvPr>
        </p:nvGraphicFramePr>
        <p:xfrm>
          <a:off x="398704" y="1350042"/>
          <a:ext cx="9822257" cy="72453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37920">
                  <a:extLst>
                    <a:ext uri="{9D8B030D-6E8A-4147-A177-3AD203B41FA5}">
                      <a16:colId xmlns:a16="http://schemas.microsoft.com/office/drawing/2014/main" val="312094600"/>
                    </a:ext>
                  </a:extLst>
                </a:gridCol>
                <a:gridCol w="1107184">
                  <a:extLst>
                    <a:ext uri="{9D8B030D-6E8A-4147-A177-3AD203B41FA5}">
                      <a16:colId xmlns:a16="http://schemas.microsoft.com/office/drawing/2014/main" val="3912103305"/>
                    </a:ext>
                  </a:extLst>
                </a:gridCol>
                <a:gridCol w="1463175">
                  <a:extLst>
                    <a:ext uri="{9D8B030D-6E8A-4147-A177-3AD203B41FA5}">
                      <a16:colId xmlns:a16="http://schemas.microsoft.com/office/drawing/2014/main" val="280245920"/>
                    </a:ext>
                  </a:extLst>
                </a:gridCol>
                <a:gridCol w="1463175">
                  <a:extLst>
                    <a:ext uri="{9D8B030D-6E8A-4147-A177-3AD203B41FA5}">
                      <a16:colId xmlns:a16="http://schemas.microsoft.com/office/drawing/2014/main" val="741674467"/>
                    </a:ext>
                  </a:extLst>
                </a:gridCol>
                <a:gridCol w="1462142">
                  <a:extLst>
                    <a:ext uri="{9D8B030D-6E8A-4147-A177-3AD203B41FA5}">
                      <a16:colId xmlns:a16="http://schemas.microsoft.com/office/drawing/2014/main" val="3421278524"/>
                    </a:ext>
                  </a:extLst>
                </a:gridCol>
                <a:gridCol w="1176318">
                  <a:extLst>
                    <a:ext uri="{9D8B030D-6E8A-4147-A177-3AD203B41FA5}">
                      <a16:colId xmlns:a16="http://schemas.microsoft.com/office/drawing/2014/main" val="4233434332"/>
                    </a:ext>
                  </a:extLst>
                </a:gridCol>
                <a:gridCol w="1112343">
                  <a:extLst>
                    <a:ext uri="{9D8B030D-6E8A-4147-A177-3AD203B41FA5}">
                      <a16:colId xmlns:a16="http://schemas.microsoft.com/office/drawing/2014/main" val="4090836006"/>
                    </a:ext>
                  </a:extLst>
                </a:gridCol>
              </a:tblGrid>
              <a:tr h="1012446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Characteristics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 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All BM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Oligo-syn-chronous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Oligo-metachronous 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Poly Met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P-value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89927860"/>
                  </a:ext>
                </a:extLst>
              </a:tr>
              <a:tr h="3262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Samples, n (%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6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6 (28.6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8 (32.1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2 (39.3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36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3392906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Gender, n (%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F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1 (55.4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6 (37.5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1 (61.1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4 (63.6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287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38988926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25 (44.6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10 (62.5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7 (38.9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8 (36.4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8017184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Age at PD (y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3 – 7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45 - 7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4 – 76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3 - 77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32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71460590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58.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0.9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8.9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6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53992204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Age at BM-OP (y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4 -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45 –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4 - 7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5 - 78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40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32261958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59.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1.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1.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7.5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7093806"/>
                  </a:ext>
                </a:extLst>
              </a:tr>
              <a:tr h="326277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Histology, n (%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AC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51 (91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22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10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89172723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SQ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 (5.4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7668834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LCNEC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 (3.6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1944663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Time btw PD &amp; BM OP (months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 – 69 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 – 6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 – 2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.997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81763169"/>
                  </a:ext>
                </a:extLst>
              </a:tr>
              <a:tr h="34308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0.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0.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.2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3587794"/>
                  </a:ext>
                </a:extLst>
              </a:tr>
              <a:tr h="326277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Neoadjuvant treatment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non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7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&lt;0.0001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55619052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I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790344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C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6348364"/>
                  </a:ext>
                </a:extLst>
              </a:tr>
              <a:tr h="3262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Survival (m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aliv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20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.154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75637456"/>
                  </a:ext>
                </a:extLst>
              </a:tr>
              <a:tr h="3262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40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dead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2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11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2783890"/>
                  </a:ext>
                </a:extLst>
              </a:tr>
              <a:tr h="6693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FUP after BM OP (m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0 -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2 - 6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0 - 59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0 -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.603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47451404"/>
                  </a:ext>
                </a:extLst>
              </a:tr>
            </a:tbl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398704" y="8961120"/>
            <a:ext cx="81989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: brain metastases, PD: Primary diagnosis, BM-OP: brain metastases operation, F: female. M: male, AC: adenocarcinoma, SQ: Squamous cell carcinoma, LCNEC: Large cell neuroendocrine carcinoma, TN: treatment-naive, IT: immunotherapy, RCT: Radio-/Chemotherapy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72615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C5EEC7F-58B6-AF9A-E042-00B7456B0DA6}"/>
              </a:ext>
            </a:extLst>
          </p:cNvPr>
          <p:cNvSpPr txBox="1"/>
          <p:nvPr/>
        </p:nvSpPr>
        <p:spPr>
          <a:xfrm>
            <a:off x="470877" y="469714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8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Table 2">
            <a:extLst>
              <a:ext uri="{FF2B5EF4-FFF2-40B4-BE49-F238E27FC236}">
                <a16:creationId xmlns:a16="http://schemas.microsoft.com/office/drawing/2014/main" id="{72406302-61D4-3FFE-10AD-EE0FAB407E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9351744"/>
              </p:ext>
            </p:extLst>
          </p:nvPr>
        </p:nvGraphicFramePr>
        <p:xfrm>
          <a:off x="694707" y="12904478"/>
          <a:ext cx="9410347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18306">
                  <a:extLst>
                    <a:ext uri="{9D8B030D-6E8A-4147-A177-3AD203B41FA5}">
                      <a16:colId xmlns:a16="http://schemas.microsoft.com/office/drawing/2014/main" val="3369131344"/>
                    </a:ext>
                  </a:extLst>
                </a:gridCol>
                <a:gridCol w="1484416">
                  <a:extLst>
                    <a:ext uri="{9D8B030D-6E8A-4147-A177-3AD203B41FA5}">
                      <a16:colId xmlns:a16="http://schemas.microsoft.com/office/drawing/2014/main" val="637487698"/>
                    </a:ext>
                  </a:extLst>
                </a:gridCol>
                <a:gridCol w="1472540">
                  <a:extLst>
                    <a:ext uri="{9D8B030D-6E8A-4147-A177-3AD203B41FA5}">
                      <a16:colId xmlns:a16="http://schemas.microsoft.com/office/drawing/2014/main" val="2229482604"/>
                    </a:ext>
                  </a:extLst>
                </a:gridCol>
                <a:gridCol w="1603169">
                  <a:extLst>
                    <a:ext uri="{9D8B030D-6E8A-4147-A177-3AD203B41FA5}">
                      <a16:colId xmlns:a16="http://schemas.microsoft.com/office/drawing/2014/main" val="182035087"/>
                    </a:ext>
                  </a:extLst>
                </a:gridCol>
                <a:gridCol w="1531916">
                  <a:extLst>
                    <a:ext uri="{9D8B030D-6E8A-4147-A177-3AD203B41FA5}">
                      <a16:colId xmlns:a16="http://schemas.microsoft.com/office/drawing/2014/main" val="345923355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Wilcoxon test (p-value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naiv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Teff type RA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>
                          <a:solidFill>
                            <a:schemeClr val="tx1"/>
                          </a:solidFill>
                        </a:rPr>
                        <a:t>C</a:t>
                      </a: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entral memor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Teff type RA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55479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untreated</a:t>
                      </a:r>
                      <a:r>
                        <a:rPr lang="en-GB" sz="16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vs </a:t>
                      </a: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poly_untreated</a:t>
                      </a:r>
                      <a:endParaRPr lang="en-DE"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0.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62729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untreated</a:t>
                      </a:r>
                      <a:r>
                        <a:rPr lang="en-GB" sz="16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vs </a:t>
                      </a: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pretreated</a:t>
                      </a:r>
                      <a:endParaRPr lang="en-DE"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 smtClean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b="0" dirty="0">
                          <a:solidFill>
                            <a:schemeClr val="tx1"/>
                          </a:solidFill>
                        </a:rPr>
                        <a:t>0.05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54494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poly_untreated</a:t>
                      </a:r>
                      <a:r>
                        <a:rPr lang="en-GB" sz="16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vs </a:t>
                      </a: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pretreated</a:t>
                      </a:r>
                      <a:endParaRPr lang="en-DE"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5209951"/>
                  </a:ext>
                </a:extLst>
              </a:tr>
            </a:tbl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4953EA94-0070-499F-53FF-DC7572C23CFC}"/>
              </a:ext>
            </a:extLst>
          </p:cNvPr>
          <p:cNvGrpSpPr/>
          <p:nvPr/>
        </p:nvGrpSpPr>
        <p:grpSpPr>
          <a:xfrm>
            <a:off x="1189924" y="1097752"/>
            <a:ext cx="8045697" cy="3756150"/>
            <a:chOff x="1189924" y="1097752"/>
            <a:chExt cx="8045697" cy="3756150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F491DD4B-1474-3852-8C5E-36E50A5ADEB3}"/>
                </a:ext>
              </a:extLst>
            </p:cNvPr>
            <p:cNvGrpSpPr/>
            <p:nvPr/>
          </p:nvGrpSpPr>
          <p:grpSpPr>
            <a:xfrm>
              <a:off x="1312695" y="1097752"/>
              <a:ext cx="7922926" cy="3756150"/>
              <a:chOff x="1312695" y="1097752"/>
              <a:chExt cx="7922926" cy="3756150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60A24E6-2599-3B9D-8C61-6E36E0E405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12695" y="1106302"/>
                <a:ext cx="1980000" cy="374760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426BB1A1-265C-2E2F-9BA6-6FE1481535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273894" y="1097752"/>
                <a:ext cx="1980527" cy="374760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455B49F8-DA47-AC52-9A55-596E6CF125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254421" y="1097752"/>
                <a:ext cx="1981200" cy="374650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2B350AA8-EBDF-9102-EAE8-2C90261FF4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292694" y="1098852"/>
                <a:ext cx="1981200" cy="3746500"/>
              </a:xfrm>
              <a:prstGeom prst="rect">
                <a:avLst/>
              </a:prstGeom>
            </p:spPr>
          </p:pic>
        </p:grpSp>
        <p:sp>
          <p:nvSpPr>
            <p:cNvPr id="19" name="TextBox 26">
              <a:extLst>
                <a:ext uri="{FF2B5EF4-FFF2-40B4-BE49-F238E27FC236}">
                  <a16:creationId xmlns:a16="http://schemas.microsoft.com/office/drawing/2014/main" id="{6915B84F-2B0C-DB38-525E-3F328200A417}"/>
                </a:ext>
              </a:extLst>
            </p:cNvPr>
            <p:cNvSpPr txBox="1"/>
            <p:nvPr/>
          </p:nvSpPr>
          <p:spPr>
            <a:xfrm>
              <a:off x="1189924" y="1097752"/>
              <a:ext cx="3742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a.</a:t>
              </a:r>
              <a:endParaRPr lang="en-DE" b="1" dirty="0">
                <a:latin typeface="Arial-BoldMT"/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482886E-6B68-897E-F868-2508135E4446}"/>
              </a:ext>
            </a:extLst>
          </p:cNvPr>
          <p:cNvGrpSpPr/>
          <p:nvPr/>
        </p:nvGrpSpPr>
        <p:grpSpPr>
          <a:xfrm>
            <a:off x="1189924" y="4998512"/>
            <a:ext cx="8046370" cy="3760394"/>
            <a:chOff x="1189924" y="4998512"/>
            <a:chExt cx="8046370" cy="376039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156D1E3-9C70-EBAB-E097-F3FDF61ED5B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11494" y="5011306"/>
              <a:ext cx="1981200" cy="37465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9454D3C-3A1A-EEB0-F1D8-4ADD152F7FD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73894" y="4998512"/>
              <a:ext cx="1981200" cy="37465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EC0D4F4-F61E-01EB-8A00-B97AE6AFE35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292694" y="5011306"/>
              <a:ext cx="1980000" cy="37476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7AF3602-89E1-EA55-9CB4-8AC919C721E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267794" y="4998512"/>
              <a:ext cx="1968500" cy="3733800"/>
            </a:xfrm>
            <a:prstGeom prst="rect">
              <a:avLst/>
            </a:prstGeom>
          </p:spPr>
        </p:pic>
        <p:sp>
          <p:nvSpPr>
            <p:cNvPr id="20" name="TextBox 26">
              <a:extLst>
                <a:ext uri="{FF2B5EF4-FFF2-40B4-BE49-F238E27FC236}">
                  <a16:creationId xmlns:a16="http://schemas.microsoft.com/office/drawing/2014/main" id="{0D2148CF-7C2F-CDFC-3384-38277250794F}"/>
                </a:ext>
              </a:extLst>
            </p:cNvPr>
            <p:cNvSpPr txBox="1"/>
            <p:nvPr/>
          </p:nvSpPr>
          <p:spPr>
            <a:xfrm>
              <a:off x="1189924" y="5010206"/>
              <a:ext cx="6040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b.</a:t>
              </a:r>
              <a:endParaRPr lang="en-DE" b="1" dirty="0">
                <a:latin typeface="Arial-BoldMT"/>
              </a:endParaRP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28953273-C276-B770-29E7-1938AFA800C5}"/>
              </a:ext>
            </a:extLst>
          </p:cNvPr>
          <p:cNvGrpSpPr/>
          <p:nvPr/>
        </p:nvGrpSpPr>
        <p:grpSpPr>
          <a:xfrm>
            <a:off x="1189924" y="8881271"/>
            <a:ext cx="8046370" cy="3763401"/>
            <a:chOff x="1189924" y="8881271"/>
            <a:chExt cx="8046370" cy="3763401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530DFC95-18DC-FC6A-42D8-05AFB3770B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267794" y="8886572"/>
              <a:ext cx="1968500" cy="374650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74760B3E-1D08-F172-D61C-94F3EA7397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292694" y="8881271"/>
              <a:ext cx="1968500" cy="37465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077892A-CAF9-763E-9351-4C96FD9654B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324194" y="8881271"/>
              <a:ext cx="1968500" cy="37465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2B4E40BD-569C-D8DA-6F02-B19FA43D7A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280244" y="8898172"/>
              <a:ext cx="1968500" cy="3746500"/>
            </a:xfrm>
            <a:prstGeom prst="rect">
              <a:avLst/>
            </a:prstGeom>
          </p:spPr>
        </p:pic>
        <p:sp>
          <p:nvSpPr>
            <p:cNvPr id="21" name="TextBox 26">
              <a:extLst>
                <a:ext uri="{FF2B5EF4-FFF2-40B4-BE49-F238E27FC236}">
                  <a16:creationId xmlns:a16="http://schemas.microsoft.com/office/drawing/2014/main" id="{675DA378-5A87-7EDE-26FA-448D26840F7D}"/>
                </a:ext>
              </a:extLst>
            </p:cNvPr>
            <p:cNvSpPr txBox="1"/>
            <p:nvPr/>
          </p:nvSpPr>
          <p:spPr>
            <a:xfrm>
              <a:off x="1189924" y="8888343"/>
              <a:ext cx="6040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c.</a:t>
              </a:r>
              <a:endParaRPr lang="en-DE" b="1" dirty="0">
                <a:latin typeface="Arial-BoldMT"/>
              </a:endParaRPr>
            </a:p>
          </p:txBody>
        </p:sp>
      </p:grpSp>
      <p:sp>
        <p:nvSpPr>
          <p:cNvPr id="24" name="Textfeld 23"/>
          <p:cNvSpPr txBox="1"/>
          <p:nvPr/>
        </p:nvSpPr>
        <p:spPr>
          <a:xfrm>
            <a:off x="666689" y="14582418"/>
            <a:ext cx="943836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pact of treatment o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cell functional differentiation profiles. (a.) comparing untreated samples from oligo- and poly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s did not alter the significant differences observed between the groups. (b.) comparing untreated samples only with pre-treated samples only in oligo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s causes a loss of all significant differences. (c.) comparing pre-treated oligo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with untreated poly metastasis showed no significant differences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0212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289408" y="705874"/>
            <a:ext cx="9977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characteristics in peripheral bloo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78780" y="12790263"/>
            <a:ext cx="81989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: brain metastases, PD: Primary diagnosis, BM-OP: brain metastases operation, F: female. M: male, AC: adenocarcinoma, SQ: Squamous cell carcinoma, LCNEC: Large cell neuroendocrine carcinoma, TN: treatment-naive, IT: immunotherapy, RCT: Radio-/Chemotherapy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5024816"/>
              </p:ext>
            </p:extLst>
          </p:nvPr>
        </p:nvGraphicFramePr>
        <p:xfrm>
          <a:off x="516092" y="1394797"/>
          <a:ext cx="8598879" cy="1043421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73965">
                  <a:extLst>
                    <a:ext uri="{9D8B030D-6E8A-4147-A177-3AD203B41FA5}">
                      <a16:colId xmlns:a16="http://schemas.microsoft.com/office/drawing/2014/main" val="1651143423"/>
                    </a:ext>
                  </a:extLst>
                </a:gridCol>
                <a:gridCol w="928914">
                  <a:extLst>
                    <a:ext uri="{9D8B030D-6E8A-4147-A177-3AD203B41FA5}">
                      <a16:colId xmlns:a16="http://schemas.microsoft.com/office/drawing/2014/main" val="3690882354"/>
                    </a:ext>
                  </a:extLst>
                </a:gridCol>
                <a:gridCol w="1059543">
                  <a:extLst>
                    <a:ext uri="{9D8B030D-6E8A-4147-A177-3AD203B41FA5}">
                      <a16:colId xmlns:a16="http://schemas.microsoft.com/office/drawing/2014/main" val="1676694641"/>
                    </a:ext>
                  </a:extLst>
                </a:gridCol>
                <a:gridCol w="1451429">
                  <a:extLst>
                    <a:ext uri="{9D8B030D-6E8A-4147-A177-3AD203B41FA5}">
                      <a16:colId xmlns:a16="http://schemas.microsoft.com/office/drawing/2014/main" val="3072896680"/>
                    </a:ext>
                  </a:extLst>
                </a:gridCol>
                <a:gridCol w="1407886">
                  <a:extLst>
                    <a:ext uri="{9D8B030D-6E8A-4147-A177-3AD203B41FA5}">
                      <a16:colId xmlns:a16="http://schemas.microsoft.com/office/drawing/2014/main" val="850004380"/>
                    </a:ext>
                  </a:extLst>
                </a:gridCol>
                <a:gridCol w="1306285">
                  <a:extLst>
                    <a:ext uri="{9D8B030D-6E8A-4147-A177-3AD203B41FA5}">
                      <a16:colId xmlns:a16="http://schemas.microsoft.com/office/drawing/2014/main" val="538796104"/>
                    </a:ext>
                  </a:extLst>
                </a:gridCol>
                <a:gridCol w="870857">
                  <a:extLst>
                    <a:ext uri="{9D8B030D-6E8A-4147-A177-3AD203B41FA5}">
                      <a16:colId xmlns:a16="http://schemas.microsoft.com/office/drawing/2014/main" val="1249996324"/>
                    </a:ext>
                  </a:extLst>
                </a:gridCol>
              </a:tblGrid>
              <a:tr h="998402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haracteristic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l BM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Oligo-synchronous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Oligo-metachronous 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oly Met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-value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666617204"/>
                  </a:ext>
                </a:extLst>
              </a:tr>
              <a:tr h="686051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amples, n 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 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4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0 (37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4 (26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0 (37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1104350860"/>
                  </a:ext>
                </a:extLst>
              </a:tr>
              <a:tr h="686051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ender, n 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F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0 (55.6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0 (50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8 (57.1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2 (60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36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791367235"/>
                  </a:ext>
                </a:extLst>
              </a:tr>
              <a:tr h="512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</a:rPr>
                        <a:t>M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4 (44.4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0 (50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6 (42.9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8 (40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9030061"/>
                  </a:ext>
                </a:extLst>
              </a:tr>
              <a:tr h="859699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ge at PD (y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3 – 7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5 – 7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4 – 7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3 – 7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1406821721"/>
                  </a:ext>
                </a:extLst>
              </a:tr>
              <a:tr h="512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</a:rPr>
                        <a:t>Mean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8.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2.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7.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6.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9939955"/>
                  </a:ext>
                </a:extLst>
              </a:tr>
              <a:tr h="859699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ge at BM-OP (y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3 – 8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45 – 8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4 – 7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5 – 7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86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4123747968"/>
                  </a:ext>
                </a:extLst>
              </a:tr>
              <a:tr h="512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</a:rPr>
                        <a:t>Mean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9.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2.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9.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7.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3690048"/>
                  </a:ext>
                </a:extLst>
              </a:tr>
              <a:tr h="338753"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Histology, n 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AC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9 (90.7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1767713702"/>
                  </a:ext>
                </a:extLst>
              </a:tr>
              <a:tr h="6860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SQ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 (5.5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4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4083247226"/>
                  </a:ext>
                </a:extLst>
              </a:tr>
              <a:tr h="166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LCNEC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 (3.7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2437258080"/>
                  </a:ext>
                </a:extLst>
              </a:tr>
              <a:tr h="686051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ime btw PD &amp; BM OP (months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 – 6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 – 6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 – 3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76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681508526"/>
                  </a:ext>
                </a:extLst>
              </a:tr>
              <a:tr h="3387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9.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2.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7.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6231226"/>
                  </a:ext>
                </a:extLst>
              </a:tr>
              <a:tr h="338753"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eoadjuvant treatment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non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&lt;0.000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4171880770"/>
                  </a:ext>
                </a:extLst>
              </a:tr>
              <a:tr h="166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I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5511633"/>
                  </a:ext>
                </a:extLst>
              </a:tr>
              <a:tr h="5281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C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6454838"/>
                  </a:ext>
                </a:extLst>
              </a:tr>
              <a:tr h="166401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urvival (m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aliv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2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6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68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391219482"/>
                  </a:ext>
                </a:extLst>
              </a:tr>
              <a:tr h="519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dead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34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4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1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3031146"/>
                  </a:ext>
                </a:extLst>
              </a:tr>
              <a:tr h="686051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FUP after BM OP (m)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 - 8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2 - 6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 - 5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 - 8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499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2056661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25094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584359" y="1235927"/>
            <a:ext cx="9977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ntibodies used for the peripheral bloo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-phenotyping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8645937"/>
              </p:ext>
            </p:extLst>
          </p:nvPr>
        </p:nvGraphicFramePr>
        <p:xfrm>
          <a:off x="584359" y="1907692"/>
          <a:ext cx="9616279" cy="768335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46546">
                  <a:extLst>
                    <a:ext uri="{9D8B030D-6E8A-4147-A177-3AD203B41FA5}">
                      <a16:colId xmlns:a16="http://schemas.microsoft.com/office/drawing/2014/main" val="2165136306"/>
                    </a:ext>
                  </a:extLst>
                </a:gridCol>
                <a:gridCol w="980015">
                  <a:extLst>
                    <a:ext uri="{9D8B030D-6E8A-4147-A177-3AD203B41FA5}">
                      <a16:colId xmlns:a16="http://schemas.microsoft.com/office/drawing/2014/main" val="4250602682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2640188195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4193733243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413211717"/>
                    </a:ext>
                  </a:extLst>
                </a:gridCol>
                <a:gridCol w="974416">
                  <a:extLst>
                    <a:ext uri="{9D8B030D-6E8A-4147-A177-3AD203B41FA5}">
                      <a16:colId xmlns:a16="http://schemas.microsoft.com/office/drawing/2014/main" val="2514261843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3366239981"/>
                    </a:ext>
                  </a:extLst>
                </a:gridCol>
                <a:gridCol w="974416">
                  <a:extLst>
                    <a:ext uri="{9D8B030D-6E8A-4147-A177-3AD203B41FA5}">
                      <a16:colId xmlns:a16="http://schemas.microsoft.com/office/drawing/2014/main" val="1271578867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505486685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505855430"/>
                    </a:ext>
                  </a:extLst>
                </a:gridCol>
              </a:tblGrid>
              <a:tr h="273517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1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2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3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4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Panel 5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1377049"/>
                  </a:ext>
                </a:extLst>
              </a:tr>
              <a:tr h="298382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T-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ell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exhaustion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T-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ell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subtype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Th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subset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T-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ell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metabolism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ytokine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5914047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solidFill>
                            <a:schemeClr val="tx1"/>
                          </a:solidFill>
                          <a:effectLst/>
                        </a:rPr>
                        <a:t>Epitope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Clon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lone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Clon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Clon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lone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63896563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25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BC96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45RA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I10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5R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I10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5R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I10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5RO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L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09386452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KLRG1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2F1/KLRG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12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A019D5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XCR3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G025H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TNF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Ab1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47212426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127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019D5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O323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16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P-3G1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FAS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DX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64591516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57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QA17A0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RPA-T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IL-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Q1-17H1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9442131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4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5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BC96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RTH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BM16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98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EM-10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20750377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BTLA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IH26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UCHT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7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Y1G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IFNg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4S.B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9470818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3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LA-D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L24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Tgd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11F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GLUT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202915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56 (surf)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5.1H1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98218084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2B4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1.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9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CR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L291H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Zombie NI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-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IL-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P4-25D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67374474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56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5.1H1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8.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XCR5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J252D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IL-10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JES3-9D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20938052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TIGIT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15153G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7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D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CR6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G034E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PD-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EH12.2H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Zombie NIR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81201313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Tim-3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F38-2E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Zombie NI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Zombie NI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8 (surf)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RPA-T8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74461735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Zombie NIR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IL-17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BL168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98311874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8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CR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G043H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S1PR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SW4GYPP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 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98350835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PD-1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EH12.2H7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 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893166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981701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716204" y="402807"/>
            <a:ext cx="59968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8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CB6BC487-C0F5-8CB2-70DB-5D01C4268ED1}"/>
              </a:ext>
            </a:extLst>
          </p:cNvPr>
          <p:cNvGrpSpPr/>
          <p:nvPr/>
        </p:nvGrpSpPr>
        <p:grpSpPr>
          <a:xfrm>
            <a:off x="341983" y="1237507"/>
            <a:ext cx="9741575" cy="10766892"/>
            <a:chOff x="341983" y="1237507"/>
            <a:chExt cx="9741575" cy="1076689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C0DD949-6228-22BB-0F26-ACE5D62783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6203" y="1237507"/>
              <a:ext cx="9367355" cy="10766892"/>
            </a:xfrm>
            <a:prstGeom prst="rect">
              <a:avLst/>
            </a:prstGeom>
          </p:spPr>
        </p:pic>
        <p:sp>
          <p:nvSpPr>
            <p:cNvPr id="5" name="TextBox 26">
              <a:extLst>
                <a:ext uri="{FF2B5EF4-FFF2-40B4-BE49-F238E27FC236}">
                  <a16:creationId xmlns:a16="http://schemas.microsoft.com/office/drawing/2014/main" id="{07271900-F20F-22CD-1A9D-EB54B0A74FE1}"/>
                </a:ext>
              </a:extLst>
            </p:cNvPr>
            <p:cNvSpPr txBox="1"/>
            <p:nvPr/>
          </p:nvSpPr>
          <p:spPr>
            <a:xfrm>
              <a:off x="341984" y="1237507"/>
              <a:ext cx="3742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a.</a:t>
              </a:r>
              <a:endParaRPr lang="en-DE" b="1" dirty="0">
                <a:latin typeface="Arial-BoldMT"/>
              </a:endParaRPr>
            </a:p>
          </p:txBody>
        </p:sp>
        <p:sp>
          <p:nvSpPr>
            <p:cNvPr id="6" name="TextBox 26">
              <a:extLst>
                <a:ext uri="{FF2B5EF4-FFF2-40B4-BE49-F238E27FC236}">
                  <a16:creationId xmlns:a16="http://schemas.microsoft.com/office/drawing/2014/main" id="{73CDAD76-194A-6016-E18D-0A03CD0181D7}"/>
                </a:ext>
              </a:extLst>
            </p:cNvPr>
            <p:cNvSpPr txBox="1"/>
            <p:nvPr/>
          </p:nvSpPr>
          <p:spPr>
            <a:xfrm>
              <a:off x="341983" y="3022765"/>
              <a:ext cx="4635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b.</a:t>
              </a:r>
              <a:endParaRPr lang="en-DE" b="1" dirty="0">
                <a:latin typeface="Arial-BoldMT"/>
              </a:endParaRPr>
            </a:p>
          </p:txBody>
        </p:sp>
        <p:sp>
          <p:nvSpPr>
            <p:cNvPr id="7" name="TextBox 26">
              <a:extLst>
                <a:ext uri="{FF2B5EF4-FFF2-40B4-BE49-F238E27FC236}">
                  <a16:creationId xmlns:a16="http://schemas.microsoft.com/office/drawing/2014/main" id="{E1048F20-787A-6CA9-A37E-A97D13F8AE5C}"/>
                </a:ext>
              </a:extLst>
            </p:cNvPr>
            <p:cNvSpPr txBox="1"/>
            <p:nvPr/>
          </p:nvSpPr>
          <p:spPr>
            <a:xfrm>
              <a:off x="341983" y="6773583"/>
              <a:ext cx="4635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c.</a:t>
              </a:r>
              <a:endParaRPr lang="en-DE" b="1" dirty="0">
                <a:latin typeface="Arial-BoldMT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529093" y="12444726"/>
            <a:ext cx="9367355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T-cell exhaustion and T-cell differentiation marker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nels 1 &amp; 2). (a.) After doublet exclusion, T-cells were selected by gating for CD3+ cells, which were further categorized based on marker expressions into CD4+ and CD8+ T-cells. T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selected as CD4+ CD25+ CD127-. (b.) Gating of T-cell exhaustion markers PD1, TIGIT, and KLRG1 on CD4+, CD8+,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(c.) T-cell differentiation populations were defined based on the expression of CD45RA, CD27, CD28 and CCR7 markers as follows: naïve (CD45RA+ CD27+ CD28+ CCR7+), T effectors type RA+ (CD45RA+, CD27−, CD28−, CCR7−), Early memory (CD45RA-, CD27+, CD28+, CCR7-), Early-like memory (CD45RA-, CD27-, CD28+, CCR7+), Intermediate (CD45RA-, CD27+, CD28-, CCR7-), Central memory (CD45RA−, CD27+, CD28+, CCR7+),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ffR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(effector memory cells: CD45RA−, CD27−, CD28−, CCR7−). CD73+ and  CD39+ cells were identified based on the expression of their respective markers on CD4+, CD8+,  and T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populations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60697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2BEF561-49C3-6E96-256B-919A0FFA4E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664" y="1267445"/>
            <a:ext cx="9524433" cy="97560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1EB671E-27D9-CC35-DB8E-C4C956E86C1B}"/>
              </a:ext>
            </a:extLst>
          </p:cNvPr>
          <p:cNvSpPr txBox="1"/>
          <p:nvPr/>
        </p:nvSpPr>
        <p:spPr>
          <a:xfrm>
            <a:off x="637664" y="621114"/>
            <a:ext cx="385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DE"/>
            </a:defPPr>
            <a:lvl1pPr>
              <a:defRPr b="1" i="0" u="none" strike="noStrike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8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dirty="0"/>
          </a:p>
        </p:txBody>
      </p:sp>
      <p:sp>
        <p:nvSpPr>
          <p:cNvPr id="4" name="Textfeld 3"/>
          <p:cNvSpPr txBox="1"/>
          <p:nvPr/>
        </p:nvSpPr>
        <p:spPr>
          <a:xfrm>
            <a:off x="637664" y="11623040"/>
            <a:ext cx="9524433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T helper cell subsets marker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anel 3). After doublet exclusion, T-cells were selected by gating for CD3+ cells. Specific T-cell subsets were identified based on marker expressions. Gamma delta T-cel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determined using the corresponding marker. T Follicular Helper cel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fh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identified by their CXCR5+ expression, while Mucosal-associated invariant T (MAIT) cells were characterized as CD4- CCR6+ CD161+. The CD45RA marker was employed to differentiate between naïve and memory T-cells, and CCR6 served as a marker for T helper cel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2 cells were defined as CCR6- CCR4+ CRTH2+, Th1 cells as CCR6- CXCR3+, Th1* cells as CCR6+ CXCR3+, and Th17 cells as CCR6+ CD161+. 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17863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F46129E-FEEE-D817-804C-E7B967E4EE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738" y="1290612"/>
            <a:ext cx="9448298" cy="538718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83A9401-3C8C-7BFE-029E-675E695D23DE}"/>
              </a:ext>
            </a:extLst>
          </p:cNvPr>
          <p:cNvSpPr txBox="1"/>
          <p:nvPr/>
        </p:nvSpPr>
        <p:spPr>
          <a:xfrm>
            <a:off x="555738" y="644281"/>
            <a:ext cx="385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DE"/>
            </a:defPPr>
            <a:lvl1pPr>
              <a:defRPr b="1" i="0" u="none" strike="noStrike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8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5E36E83-0C5E-4B1C-561D-3ADA8EF130BD}"/>
              </a:ext>
            </a:extLst>
          </p:cNvPr>
          <p:cNvSpPr txBox="1"/>
          <p:nvPr/>
        </p:nvSpPr>
        <p:spPr>
          <a:xfrm>
            <a:off x="808891" y="7104185"/>
            <a:ext cx="91951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D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endParaRPr lang="en-DE" dirty="0"/>
          </a:p>
        </p:txBody>
      </p:sp>
      <p:sp>
        <p:nvSpPr>
          <p:cNvPr id="5" name="Textfeld 4"/>
          <p:cNvSpPr txBox="1"/>
          <p:nvPr/>
        </p:nvSpPr>
        <p:spPr>
          <a:xfrm>
            <a:off x="808891" y="7156043"/>
            <a:ext cx="877756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T-cell metabolism markers (panel 4)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doublet exclusion, T-cells were selected by gating on CD3+ cells, which were further categorized based on marker expressions into CD4+ and CD8+ T-cells. PD-1+, GLUT1+, CD71+, FAS+, and CD89+ expressing cells are identified by their corresponding markers on CD4+ and CD8+ cells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61495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25D73AF-FF99-11BC-0A0D-AEC7BE6DF6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4492" y="1526639"/>
            <a:ext cx="9110777" cy="868046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648AAB2-9BD8-DFF4-9E7F-1DE1AF37A067}"/>
              </a:ext>
            </a:extLst>
          </p:cNvPr>
          <p:cNvSpPr txBox="1"/>
          <p:nvPr/>
        </p:nvSpPr>
        <p:spPr>
          <a:xfrm>
            <a:off x="844492" y="643885"/>
            <a:ext cx="385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DE"/>
            </a:defPPr>
            <a:lvl1pPr>
              <a:defRPr b="1" i="0" u="none" strike="noStrike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8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844492" y="11061292"/>
            <a:ext cx="831809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cytokines markers (panel 5)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doublet exclusion, T-cells were selected by gating on CD3+ cells, which were further categorized based on marker expressions into CD4+ and CD8+ T-cells. NK cells were identified as CD56+ cells. The cytokines markers, including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F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2, IL4, IL10, and IL17 were determined based on their corresponding markers expressions on CD4+, CD8+, and NK cells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17837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CEFD99E-A724-2224-D494-F2BA557B7C20}"/>
              </a:ext>
            </a:extLst>
          </p:cNvPr>
          <p:cNvSpPr txBox="1"/>
          <p:nvPr/>
        </p:nvSpPr>
        <p:spPr>
          <a:xfrm>
            <a:off x="466588" y="601858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26">
            <a:extLst>
              <a:ext uri="{FF2B5EF4-FFF2-40B4-BE49-F238E27FC236}">
                <a16:creationId xmlns:a16="http://schemas.microsoft.com/office/drawing/2014/main" id="{FCFBB5E4-96BA-ABC3-EF6B-6C3C119EFA96}"/>
              </a:ext>
            </a:extLst>
          </p:cNvPr>
          <p:cNvSpPr txBox="1"/>
          <p:nvPr/>
        </p:nvSpPr>
        <p:spPr>
          <a:xfrm>
            <a:off x="475429" y="920626"/>
            <a:ext cx="374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-BoldMT"/>
              </a:rPr>
              <a:t>a.</a:t>
            </a:r>
            <a:endParaRPr lang="en-DE" b="1" dirty="0">
              <a:latin typeface="Arial-BoldMT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A56F729-ABE5-079D-E734-E163686A37C6}"/>
              </a:ext>
            </a:extLst>
          </p:cNvPr>
          <p:cNvGrpSpPr/>
          <p:nvPr/>
        </p:nvGrpSpPr>
        <p:grpSpPr>
          <a:xfrm>
            <a:off x="466588" y="971190"/>
            <a:ext cx="8037023" cy="9837588"/>
            <a:chOff x="466588" y="971190"/>
            <a:chExt cx="8037023" cy="983758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DDB48237-13BB-1963-DF13-59476DDA36BE}"/>
                </a:ext>
              </a:extLst>
            </p:cNvPr>
            <p:cNvGrpSpPr/>
            <p:nvPr/>
          </p:nvGrpSpPr>
          <p:grpSpPr>
            <a:xfrm>
              <a:off x="466588" y="971190"/>
              <a:ext cx="8037023" cy="6171401"/>
              <a:chOff x="466588" y="971190"/>
              <a:chExt cx="8037023" cy="6171401"/>
            </a:xfrm>
          </p:grpSpPr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7D0C4FE1-3F6B-A6C6-088F-8B5F70CD90C0}"/>
                  </a:ext>
                </a:extLst>
              </p:cNvPr>
              <p:cNvGrpSpPr/>
              <p:nvPr/>
            </p:nvGrpSpPr>
            <p:grpSpPr>
              <a:xfrm>
                <a:off x="920031" y="4385564"/>
                <a:ext cx="7568169" cy="2757027"/>
                <a:chOff x="504462" y="7712988"/>
                <a:chExt cx="7568169" cy="2757027"/>
              </a:xfrm>
            </p:grpSpPr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4ABFC888-CF34-635C-27A6-0719A57CFD80}"/>
                    </a:ext>
                  </a:extLst>
                </p:cNvPr>
                <p:cNvSpPr txBox="1"/>
                <p:nvPr/>
              </p:nvSpPr>
              <p:spPr>
                <a:xfrm>
                  <a:off x="5012596" y="7712988"/>
                  <a:ext cx="94429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DE"/>
                  </a:defPPr>
                  <a:lvl1pPr>
                    <a:defRPr sz="140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endParaRPr lang="en-DE" dirty="0"/>
                </a:p>
              </p:txBody>
            </p:sp>
            <p:pic>
              <p:nvPicPr>
                <p:cNvPr id="21" name="Picture 20" descr="A picture containing honeycomb, bread&#10;&#10;Description automatically generated">
                  <a:extLst>
                    <a:ext uri="{FF2B5EF4-FFF2-40B4-BE49-F238E27FC236}">
                      <a16:creationId xmlns:a16="http://schemas.microsoft.com/office/drawing/2014/main" id="{82FCFDAA-75AB-549D-E3F5-41033B2B72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199"/>
                <a:stretch/>
              </p:blipFill>
              <p:spPr>
                <a:xfrm>
                  <a:off x="4502372" y="7987484"/>
                  <a:ext cx="3570259" cy="2482531"/>
                </a:xfrm>
                <a:prstGeom prst="rect">
                  <a:avLst/>
                </a:prstGeom>
              </p:spPr>
            </p:pic>
            <p:pic>
              <p:nvPicPr>
                <p:cNvPr id="36" name="Picture 35" descr="Background pattern&#10;&#10;Description automatically generated">
                  <a:extLst>
                    <a:ext uri="{FF2B5EF4-FFF2-40B4-BE49-F238E27FC236}">
                      <a16:creationId xmlns:a16="http://schemas.microsoft.com/office/drawing/2014/main" id="{977BE134-82B1-368A-E2F2-577CB7EA9C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199"/>
                <a:stretch/>
              </p:blipFill>
              <p:spPr>
                <a:xfrm>
                  <a:off x="504462" y="7987484"/>
                  <a:ext cx="3485189" cy="2430881"/>
                </a:xfrm>
                <a:prstGeom prst="rect">
                  <a:avLst/>
                </a:prstGeom>
              </p:spPr>
            </p:pic>
          </p:grpSp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F085FBBC-8AC4-0074-A95B-BED8D8C7D8B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944"/>
              <a:stretch/>
            </p:blipFill>
            <p:spPr>
              <a:xfrm>
                <a:off x="4917941" y="1406816"/>
                <a:ext cx="3535554" cy="2482531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221FD89-B2C1-D069-B319-EBDC8B974B49}"/>
                  </a:ext>
                </a:extLst>
              </p:cNvPr>
              <p:cNvSpPr txBox="1"/>
              <p:nvPr/>
            </p:nvSpPr>
            <p:spPr>
              <a:xfrm>
                <a:off x="4002750" y="971190"/>
                <a:ext cx="131765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>
                    <a:latin typeface="Arial-BoldMT"/>
                  </a:rPr>
                  <a:t>CD68</a:t>
                </a:r>
                <a:endParaRPr lang="en-DE" b="1" dirty="0">
                  <a:latin typeface="Arial-BoldMT"/>
                </a:endParaRPr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3B93DF36-96FE-F828-4A59-3DA75F3314F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69666" y="1289958"/>
                <a:ext cx="7583829" cy="11768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D0881CE-E3C4-A8D0-8F68-43672E7696A6}"/>
                  </a:ext>
                </a:extLst>
              </p:cNvPr>
              <p:cNvSpPr txBox="1"/>
              <p:nvPr/>
            </p:nvSpPr>
            <p:spPr>
              <a:xfrm rot="16200000">
                <a:off x="-294071" y="2457198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IT</a:t>
                </a:r>
                <a:r>
                  <a:rPr lang="en-US" i="0" u="none" strike="noStrike" baseline="0" dirty="0">
                    <a:latin typeface="ArialMT"/>
                  </a:rPr>
                  <a:t> </a:t>
                </a:r>
                <a:r>
                  <a:rPr lang="en-US" dirty="0">
                    <a:latin typeface="Arial-BoldMT"/>
                  </a:rPr>
                  <a:t>low PT high</a:t>
                </a:r>
                <a:endParaRPr lang="en-DE" dirty="0">
                  <a:latin typeface="Arial-BoldMT"/>
                </a:endParaRPr>
              </a:p>
            </p:txBody>
          </p:sp>
          <p:pic>
            <p:nvPicPr>
              <p:cNvPr id="47" name="Picture 46" descr="Map&#10;&#10;Description automatically generated with medium confidence">
                <a:extLst>
                  <a:ext uri="{FF2B5EF4-FFF2-40B4-BE49-F238E27FC236}">
                    <a16:creationId xmlns:a16="http://schemas.microsoft.com/office/drawing/2014/main" id="{0B1D77F9-7FCF-9F1D-5082-5B5A76C221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643"/>
              <a:stretch/>
            </p:blipFill>
            <p:spPr>
              <a:xfrm>
                <a:off x="869666" y="1406817"/>
                <a:ext cx="3535554" cy="2481921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79EF1B4-CC60-4D93-48DE-4513A167B9D0}"/>
                  </a:ext>
                </a:extLst>
              </p:cNvPr>
              <p:cNvSpPr txBox="1"/>
              <p:nvPr/>
            </p:nvSpPr>
            <p:spPr>
              <a:xfrm rot="16200000">
                <a:off x="3785505" y="2413614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IT</a:t>
                </a:r>
                <a:r>
                  <a:rPr lang="en-US" i="0" u="none" strike="noStrike" baseline="0" dirty="0">
                    <a:latin typeface="ArialMT"/>
                  </a:rPr>
                  <a:t> </a:t>
                </a:r>
                <a:r>
                  <a:rPr lang="en-US" dirty="0">
                    <a:latin typeface="Arial-BoldMT"/>
                  </a:rPr>
                  <a:t>&amp; PT high</a:t>
                </a:r>
                <a:endParaRPr lang="en-DE" dirty="0">
                  <a:latin typeface="Arial-BoldMT"/>
                </a:endParaRPr>
              </a:p>
            </p:txBody>
          </p:sp>
          <p:sp>
            <p:nvSpPr>
              <p:cNvPr id="26" name="TextBox 26">
                <a:extLst>
                  <a:ext uri="{FF2B5EF4-FFF2-40B4-BE49-F238E27FC236}">
                    <a16:creationId xmlns:a16="http://schemas.microsoft.com/office/drawing/2014/main" id="{DFA63F90-CC16-F3BE-8AD6-F3FCD2917AEF}"/>
                  </a:ext>
                </a:extLst>
              </p:cNvPr>
              <p:cNvSpPr txBox="1"/>
              <p:nvPr/>
            </p:nvSpPr>
            <p:spPr>
              <a:xfrm>
                <a:off x="466588" y="4210996"/>
                <a:ext cx="4534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latin typeface="Arial-BoldMT"/>
                  </a:rPr>
                  <a:t>b.</a:t>
                </a:r>
                <a:endParaRPr lang="en-DE" b="1" dirty="0">
                  <a:latin typeface="Arial-BoldMT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04BAA1B-B222-5F78-F444-CC9188FFD1AF}"/>
                  </a:ext>
                </a:extLst>
              </p:cNvPr>
              <p:cNvSpPr txBox="1"/>
              <p:nvPr/>
            </p:nvSpPr>
            <p:spPr>
              <a:xfrm rot="16200000">
                <a:off x="-282788" y="5716659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low</a:t>
                </a:r>
                <a:endParaRPr lang="en-DE" dirty="0">
                  <a:latin typeface="Arial-BoldMT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9152C44-5070-0CC0-A475-462FB007F517}"/>
                  </a:ext>
                </a:extLst>
              </p:cNvPr>
              <p:cNvSpPr txBox="1"/>
              <p:nvPr/>
            </p:nvSpPr>
            <p:spPr>
              <a:xfrm rot="16200000">
                <a:off x="3785505" y="5716658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high</a:t>
                </a:r>
                <a:endParaRPr lang="en-DE" dirty="0">
                  <a:latin typeface="Arial-BoldMT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C50D5F2-8428-BB46-24C1-25B5397FF979}"/>
                  </a:ext>
                </a:extLst>
              </p:cNvPr>
              <p:cNvSpPr txBox="1"/>
              <p:nvPr/>
            </p:nvSpPr>
            <p:spPr>
              <a:xfrm>
                <a:off x="4052866" y="4214315"/>
                <a:ext cx="131765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>
                    <a:latin typeface="Arial-BoldMT"/>
                  </a:rPr>
                  <a:t>Ki67</a:t>
                </a:r>
                <a:endParaRPr lang="en-DE" b="1" dirty="0">
                  <a:latin typeface="Arial-BoldMT"/>
                </a:endParaRPr>
              </a:p>
            </p:txBody>
          </p: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ED451D17-2BAE-E1AC-22F6-1E3942A3230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19782" y="4533083"/>
                <a:ext cx="7583829" cy="11768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E7B6C301-65F4-BD2E-474E-738959F8647E}"/>
                </a:ext>
              </a:extLst>
            </p:cNvPr>
            <p:cNvGrpSpPr/>
            <p:nvPr/>
          </p:nvGrpSpPr>
          <p:grpSpPr>
            <a:xfrm>
              <a:off x="565420" y="7293519"/>
              <a:ext cx="4834461" cy="3515259"/>
              <a:chOff x="565420" y="7293519"/>
              <a:chExt cx="4834461" cy="3515259"/>
            </a:xfrm>
          </p:grpSpPr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F653311B-D5F9-B618-D104-8E52EC4D1ACF}"/>
                  </a:ext>
                </a:extLst>
              </p:cNvPr>
              <p:cNvGrpSpPr/>
              <p:nvPr/>
            </p:nvGrpSpPr>
            <p:grpSpPr>
              <a:xfrm>
                <a:off x="3487743" y="7293519"/>
                <a:ext cx="1223952" cy="415380"/>
                <a:chOff x="1133339" y="8349499"/>
                <a:chExt cx="1317658" cy="415380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964FBEA5-C25F-5DC3-F019-9B3C7FD7E015}"/>
                    </a:ext>
                  </a:extLst>
                </p:cNvPr>
                <p:cNvSpPr txBox="1"/>
                <p:nvPr/>
              </p:nvSpPr>
              <p:spPr>
                <a:xfrm>
                  <a:off x="1133339" y="8349499"/>
                  <a:ext cx="131765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b="1" dirty="0">
                      <a:latin typeface="Arial-BoldMT"/>
                    </a:rPr>
                    <a:t>Ki67</a:t>
                  </a:r>
                  <a:endParaRPr lang="en-DE" b="1" dirty="0">
                    <a:latin typeface="Arial-BoldMT"/>
                  </a:endParaRPr>
                </a:p>
              </p:txBody>
            </p:sp>
            <p:cxnSp>
              <p:nvCxnSpPr>
                <p:cNvPr id="57" name="Straight Connector 56">
                  <a:extLst>
                    <a:ext uri="{FF2B5EF4-FFF2-40B4-BE49-F238E27FC236}">
                      <a16:creationId xmlns:a16="http://schemas.microsoft.com/office/drawing/2014/main" id="{A67437D8-59FF-8F49-22C6-A2FA17DB47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445021" y="8764879"/>
                  <a:ext cx="676037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" name="TextBox 26">
                <a:extLst>
                  <a:ext uri="{FF2B5EF4-FFF2-40B4-BE49-F238E27FC236}">
                    <a16:creationId xmlns:a16="http://schemas.microsoft.com/office/drawing/2014/main" id="{747106C9-0F87-00CE-94C8-CFE0A3B04F92}"/>
                  </a:ext>
                </a:extLst>
              </p:cNvPr>
              <p:cNvSpPr txBox="1"/>
              <p:nvPr/>
            </p:nvSpPr>
            <p:spPr>
              <a:xfrm>
                <a:off x="565420" y="7316543"/>
                <a:ext cx="4534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latin typeface="Arial-BoldMT"/>
                  </a:rPr>
                  <a:t>c.</a:t>
                </a:r>
                <a:endParaRPr lang="en-DE" b="1" dirty="0">
                  <a:latin typeface="Arial-BoldMT"/>
                </a:endParaRP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72903179-951A-CCAA-4D47-98B80DB1E6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9471" r="29225"/>
              <a:stretch/>
            </p:blipFill>
            <p:spPr>
              <a:xfrm>
                <a:off x="916209" y="7911477"/>
                <a:ext cx="2319011" cy="2897301"/>
              </a:xfrm>
              <a:prstGeom prst="rect">
                <a:avLst/>
              </a:prstGeom>
            </p:spPr>
          </p:pic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58587EA5-6D1F-FF6C-83D5-8C2EFF43C827}"/>
                  </a:ext>
                </a:extLst>
              </p:cNvPr>
              <p:cNvGrpSpPr/>
              <p:nvPr/>
            </p:nvGrpSpPr>
            <p:grpSpPr>
              <a:xfrm>
                <a:off x="1361398" y="7293519"/>
                <a:ext cx="1817651" cy="784712"/>
                <a:chOff x="884106" y="8352051"/>
                <a:chExt cx="1956808" cy="784712"/>
              </a:xfrm>
            </p:grpSpPr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F320245A-4959-B1E5-0BC6-93FAC742DADB}"/>
                    </a:ext>
                  </a:extLst>
                </p:cNvPr>
                <p:cNvGrpSpPr/>
                <p:nvPr/>
              </p:nvGrpSpPr>
              <p:grpSpPr>
                <a:xfrm>
                  <a:off x="952603" y="8352051"/>
                  <a:ext cx="1838782" cy="415380"/>
                  <a:chOff x="952603" y="8352051"/>
                  <a:chExt cx="1838782" cy="415380"/>
                </a:xfrm>
              </p:grpSpPr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C027114B-B81D-E91B-3F31-C3DB4B592B92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785" y="8352051"/>
                    <a:ext cx="13176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b="1" dirty="0">
                        <a:latin typeface="Arial-BoldMT"/>
                      </a:rPr>
                      <a:t>CD68</a:t>
                    </a:r>
                    <a:endParaRPr lang="en-DE" b="1" dirty="0">
                      <a:latin typeface="Arial-BoldMT"/>
                    </a:endParaRPr>
                  </a:p>
                </p:txBody>
              </p:sp>
              <p:cxnSp>
                <p:nvCxnSpPr>
                  <p:cNvPr id="20" name="Straight Connector 19">
                    <a:extLst>
                      <a:ext uri="{FF2B5EF4-FFF2-40B4-BE49-F238E27FC236}">
                        <a16:creationId xmlns:a16="http://schemas.microsoft.com/office/drawing/2014/main" id="{557A5871-316B-7F99-405F-FAD8149F24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952603" y="8767431"/>
                    <a:ext cx="1838782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48AA70A8-124B-1DD7-6569-E686145B778A}"/>
                    </a:ext>
                  </a:extLst>
                </p:cNvPr>
                <p:cNvSpPr txBox="1"/>
                <p:nvPr/>
              </p:nvSpPr>
              <p:spPr>
                <a:xfrm>
                  <a:off x="884106" y="8767431"/>
                  <a:ext cx="83340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dirty="0">
                      <a:latin typeface="Arial-BoldMT"/>
                    </a:rPr>
                    <a:t>IT</a:t>
                  </a:r>
                  <a:endParaRPr lang="en-DE" dirty="0">
                    <a:latin typeface="Arial-BoldMT"/>
                  </a:endParaRP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CDA5F254-4DB5-B9BF-2FD4-7CD583AEDC5E}"/>
                    </a:ext>
                  </a:extLst>
                </p:cNvPr>
                <p:cNvSpPr txBox="1"/>
                <p:nvPr/>
              </p:nvSpPr>
              <p:spPr>
                <a:xfrm>
                  <a:off x="2145811" y="8767431"/>
                  <a:ext cx="69510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dirty="0">
                      <a:latin typeface="Arial-BoldMT"/>
                    </a:rPr>
                    <a:t>PT</a:t>
                  </a:r>
                  <a:endParaRPr lang="en-DE" dirty="0">
                    <a:latin typeface="Arial-BoldMT"/>
                  </a:endParaRPr>
                </a:p>
              </p:txBody>
            </p:sp>
          </p:grpSp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2E3C418A-95CF-4D2B-AAA3-AB352FEB0A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7275"/>
              <a:stretch/>
            </p:blipFill>
            <p:spPr>
              <a:xfrm>
                <a:off x="3367881" y="7871965"/>
                <a:ext cx="2032000" cy="2841634"/>
              </a:xfrm>
              <a:prstGeom prst="rect">
                <a:avLst/>
              </a:prstGeom>
            </p:spPr>
          </p:pic>
        </p:grpSp>
      </p:grpSp>
      <p:sp>
        <p:nvSpPr>
          <p:cNvPr id="6" name="Textfeld 5"/>
          <p:cNvSpPr txBox="1"/>
          <p:nvPr/>
        </p:nvSpPr>
        <p:spPr>
          <a:xfrm>
            <a:off x="466588" y="11298540"/>
            <a:ext cx="943836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histochemic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tection and estimation of positive staining for CD68 and Ki67 on brain metastasis tissue samples.  (a.) Representative staining of CD68 in IT and PT regions (high and low infiltration). Magnification: x20. (b.) Representative images of the high and low positive staining percentage of Ki67 in tumor tissues. Magnification: x20. (c.) Comparison of the staining scores for CD68 in both IT and PT regions, and Ki67 in tumor tissues between BM groups. (Sync: oligo-synchronous BM, Meta: oligo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chronou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M, and poly: poly metastasis), (negative: no stained cells, low: &lt;10%, moderate:10-40%, and high: &gt;40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51551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D341191-FFAA-6E6A-B308-F5C0E02A5A09}"/>
              </a:ext>
            </a:extLst>
          </p:cNvPr>
          <p:cNvSpPr txBox="1"/>
          <p:nvPr/>
        </p:nvSpPr>
        <p:spPr>
          <a:xfrm>
            <a:off x="470877" y="469714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11990F7E-23C2-1792-CE00-C9533F3E50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251" y="9359667"/>
            <a:ext cx="3206339" cy="247965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3298CDD-0801-5F09-F1BB-656CAB45ED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251" y="6818155"/>
            <a:ext cx="3164643" cy="244740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12FA07AC-57EC-5ED7-0CC9-71353F575E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1590" y="6818155"/>
            <a:ext cx="3164643" cy="2447408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5A3A2C4-E424-38FC-059B-B0DFDAB9A2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31590" y="3753075"/>
            <a:ext cx="3164643" cy="244740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5E76E85F-B0DD-14B0-100E-26438FB648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86848" y="1211283"/>
            <a:ext cx="3164642" cy="244740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FC4DFAAE-2D51-8C0D-005B-D462F0088F8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1767" y="1211283"/>
            <a:ext cx="3164642" cy="2447407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65D986D4-D564-080D-61A8-B6D7C5529D6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1767" y="3753075"/>
            <a:ext cx="3164642" cy="2447407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3D473193-121E-D005-F795-7E6DF9E2049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28971" y="3753075"/>
            <a:ext cx="3164642" cy="2447407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8D1AABA-EC24-79B1-605B-C8D809F20D9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28971" y="1211283"/>
            <a:ext cx="3164642" cy="2447407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1784350" y="1216931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3 IT</a:t>
            </a:r>
            <a:endParaRPr lang="en-US" sz="1100" dirty="0"/>
          </a:p>
        </p:txBody>
      </p:sp>
      <p:sp>
        <p:nvSpPr>
          <p:cNvPr id="13" name="Textfeld 12"/>
          <p:cNvSpPr txBox="1"/>
          <p:nvPr/>
        </p:nvSpPr>
        <p:spPr>
          <a:xfrm>
            <a:off x="5029200" y="1211283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8 IT</a:t>
            </a:r>
            <a:endParaRPr lang="en-US" sz="1100" dirty="0"/>
          </a:p>
        </p:txBody>
      </p:sp>
      <p:sp>
        <p:nvSpPr>
          <p:cNvPr id="14" name="Textfeld 13"/>
          <p:cNvSpPr txBox="1"/>
          <p:nvPr/>
        </p:nvSpPr>
        <p:spPr>
          <a:xfrm>
            <a:off x="8255000" y="1200821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4 IT</a:t>
            </a:r>
            <a:endParaRPr lang="en-US" sz="1100" dirty="0"/>
          </a:p>
        </p:txBody>
      </p:sp>
      <p:sp>
        <p:nvSpPr>
          <p:cNvPr id="15" name="Textfeld 14"/>
          <p:cNvSpPr txBox="1"/>
          <p:nvPr/>
        </p:nvSpPr>
        <p:spPr>
          <a:xfrm>
            <a:off x="1760231" y="3752794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3 IT</a:t>
            </a:r>
            <a:endParaRPr lang="en-US" sz="1100" dirty="0"/>
          </a:p>
        </p:txBody>
      </p:sp>
      <p:sp>
        <p:nvSpPr>
          <p:cNvPr id="16" name="Textfeld 15"/>
          <p:cNvSpPr txBox="1"/>
          <p:nvPr/>
        </p:nvSpPr>
        <p:spPr>
          <a:xfrm>
            <a:off x="5005081" y="3747146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8 IT</a:t>
            </a:r>
            <a:endParaRPr lang="en-US" sz="1100" dirty="0"/>
          </a:p>
        </p:txBody>
      </p:sp>
      <p:sp>
        <p:nvSpPr>
          <p:cNvPr id="17" name="Textfeld 16"/>
          <p:cNvSpPr txBox="1"/>
          <p:nvPr/>
        </p:nvSpPr>
        <p:spPr>
          <a:xfrm>
            <a:off x="8230881" y="3736684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4 IT</a:t>
            </a:r>
            <a:endParaRPr lang="en-US" sz="1100" dirty="0"/>
          </a:p>
        </p:txBody>
      </p:sp>
      <p:sp>
        <p:nvSpPr>
          <p:cNvPr id="18" name="Textfeld 17"/>
          <p:cNvSpPr txBox="1"/>
          <p:nvPr/>
        </p:nvSpPr>
        <p:spPr>
          <a:xfrm>
            <a:off x="1826906" y="6773369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68 IT</a:t>
            </a:r>
            <a:endParaRPr lang="en-US" sz="1100" dirty="0"/>
          </a:p>
        </p:txBody>
      </p:sp>
      <p:sp>
        <p:nvSpPr>
          <p:cNvPr id="19" name="Textfeld 18"/>
          <p:cNvSpPr txBox="1"/>
          <p:nvPr/>
        </p:nvSpPr>
        <p:spPr>
          <a:xfrm>
            <a:off x="5071756" y="6767721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Ki67 tumor</a:t>
            </a:r>
            <a:endParaRPr lang="en-US" sz="1100" dirty="0"/>
          </a:p>
        </p:txBody>
      </p:sp>
      <p:sp>
        <p:nvSpPr>
          <p:cNvPr id="20" name="Textfeld 19"/>
          <p:cNvSpPr txBox="1"/>
          <p:nvPr/>
        </p:nvSpPr>
        <p:spPr>
          <a:xfrm>
            <a:off x="1784350" y="9390979"/>
            <a:ext cx="1041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68 PT</a:t>
            </a:r>
            <a:endParaRPr lang="en-US" sz="1100" dirty="0"/>
          </a:p>
        </p:txBody>
      </p:sp>
      <p:cxnSp>
        <p:nvCxnSpPr>
          <p:cNvPr id="23" name="Gerader Verbinder 22"/>
          <p:cNvCxnSpPr/>
          <p:nvPr/>
        </p:nvCxnSpPr>
        <p:spPr>
          <a:xfrm>
            <a:off x="4866968" y="10356726"/>
            <a:ext cx="409575" cy="7694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feld 4"/>
          <p:cNvSpPr txBox="1"/>
          <p:nvPr/>
        </p:nvSpPr>
        <p:spPr>
          <a:xfrm>
            <a:off x="5276543" y="10225920"/>
            <a:ext cx="13767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High infiltration</a:t>
            </a:r>
            <a:endParaRPr lang="en-US" sz="1400" dirty="0"/>
          </a:p>
        </p:txBody>
      </p:sp>
      <p:cxnSp>
        <p:nvCxnSpPr>
          <p:cNvPr id="30" name="Gerader Verbinder 29"/>
          <p:cNvCxnSpPr/>
          <p:nvPr/>
        </p:nvCxnSpPr>
        <p:spPr>
          <a:xfrm>
            <a:off x="4866968" y="10634189"/>
            <a:ext cx="409575" cy="7694"/>
          </a:xfrm>
          <a:prstGeom prst="line">
            <a:avLst/>
          </a:prstGeom>
          <a:ln w="3810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5276543" y="10503383"/>
            <a:ext cx="12917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Low </a:t>
            </a:r>
            <a:r>
              <a:rPr lang="en-US" sz="1400" dirty="0"/>
              <a:t>infiltration</a:t>
            </a:r>
          </a:p>
          <a:p>
            <a:endParaRPr lang="en-US" sz="1400" dirty="0"/>
          </a:p>
        </p:txBody>
      </p:sp>
      <p:sp>
        <p:nvSpPr>
          <p:cNvPr id="8" name="Rechteck 7"/>
          <p:cNvSpPr/>
          <p:nvPr/>
        </p:nvSpPr>
        <p:spPr>
          <a:xfrm>
            <a:off x="4646306" y="10131579"/>
            <a:ext cx="2083224" cy="6631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feld 25"/>
          <p:cNvSpPr txBox="1"/>
          <p:nvPr/>
        </p:nvSpPr>
        <p:spPr>
          <a:xfrm>
            <a:off x="470877" y="12471022"/>
            <a:ext cx="943836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 curves (24m) based of differentially infiltration of CD3, CD8, CD4, and CD68 immune cells in intra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T)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i-tumor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T) regions, and Ki67 expression in tumor tissue. </a:t>
            </a:r>
          </a:p>
        </p:txBody>
      </p:sp>
    </p:spTree>
    <p:extLst>
      <p:ext uri="{BB962C8B-B14F-4D97-AF65-F5344CB8AC3E}">
        <p14:creationId xmlns:p14="http://schemas.microsoft.com/office/powerpoint/2010/main" val="3857762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89</Words>
  <Application>Microsoft Office PowerPoint</Application>
  <PresentationFormat>Benutzerdefiniert</PresentationFormat>
  <Paragraphs>464</Paragraphs>
  <Slides>1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7" baseType="lpstr">
      <vt:lpstr>Arial</vt:lpstr>
      <vt:lpstr>Arial-BoldMT</vt:lpstr>
      <vt:lpstr>ArialMT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is Alsousli</dc:creator>
  <cp:lastModifiedBy>ITB_174242</cp:lastModifiedBy>
  <cp:revision>299</cp:revision>
  <cp:lastPrinted>2022-12-15T15:39:17Z</cp:lastPrinted>
  <dcterms:created xsi:type="dcterms:W3CDTF">2022-10-18T13:18:59Z</dcterms:created>
  <dcterms:modified xsi:type="dcterms:W3CDTF">2024-04-10T10:22:58Z</dcterms:modified>
</cp:coreProperties>
</file>